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41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L:\Research%20II\Desktop\2011-2012%20projects\Saudi%20KFSH%20project\Abs%20elut%20analysis\022012%20Saudi%20LS2A01009_ID93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b="0"/>
            </a:pPr>
            <a:r>
              <a:rPr lang="en-US" b="0"/>
              <a:t>Antibody</a:t>
            </a:r>
            <a:r>
              <a:rPr lang="en-US" b="0" baseline="0"/>
              <a:t> eluted from DQA1*02:01/DQB1*04:01 rHLA DQ cells </a:t>
            </a:r>
            <a:endParaRPr lang="en-US" b="0"/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strRef>
              <c:f>'Saudi ID93#23 09-146 4 hindawi'!$A$11</c:f>
              <c:strCache>
                <c:ptCount val="1"/>
                <c:pt idx="0">
                  <c:v>#23 RC2265 A DQ4-DQ401.201</c:v>
                </c:pt>
              </c:strCache>
            </c:strRef>
          </c:tx>
          <c:spPr>
            <a:solidFill>
              <a:schemeClr val="accent2"/>
            </a:solidFill>
          </c:spPr>
          <c:cat>
            <c:strRef>
              <c:f>'Saudi ID93#23 09-146 4 hindawi'!$B$10:$AD$10</c:f>
              <c:strCache>
                <c:ptCount val="29"/>
                <c:pt idx="0">
                  <c:v>DQA1*02:01\DQB1*02:01 (DQ2)</c:v>
                </c:pt>
                <c:pt idx="1">
                  <c:v>DQA1*02:01\DQB1*02:02 (DQ2)</c:v>
                </c:pt>
                <c:pt idx="2">
                  <c:v>DQA1*03:01\DQB1*02:01 (DQ2)</c:v>
                </c:pt>
                <c:pt idx="3">
                  <c:v>DQA1*04:01\DQB1*02:01 (DQ2)</c:v>
                </c:pt>
                <c:pt idx="4">
                  <c:v>DQA1*05:01\DQB1*02:01 (DQ2)</c:v>
                </c:pt>
                <c:pt idx="5">
                  <c:v>DQA1*02:01\DQB1*04:01 (DQ4)</c:v>
                </c:pt>
                <c:pt idx="6">
                  <c:v>DQA1*02:01\DQB1*04:02 (DQ4)</c:v>
                </c:pt>
                <c:pt idx="7">
                  <c:v>DQA1*03:03\DQB1*04:01 (DQ4)</c:v>
                </c:pt>
                <c:pt idx="8">
                  <c:v>DQA1*04:01\DQB1*04:02 (DQ4)</c:v>
                </c:pt>
                <c:pt idx="9">
                  <c:v>DQA1*01:01\DQB1*05:01 (DQ5)</c:v>
                </c:pt>
                <c:pt idx="10">
                  <c:v>DQA1*01:02\DQB1*05:02 (DQ5)</c:v>
                </c:pt>
                <c:pt idx="11">
                  <c:v>DQA1*01:01\DQB1*06:02 (DQ6)</c:v>
                </c:pt>
                <c:pt idx="12">
                  <c:v>DQA1*01:02\DQB1*06:02 (DQ6)</c:v>
                </c:pt>
                <c:pt idx="13">
                  <c:v>DQA1*01:02\DQB1*06:04 (DQ6)</c:v>
                </c:pt>
                <c:pt idx="14">
                  <c:v>DQA1*01:02\DQB1*06:09 (DQ6)</c:v>
                </c:pt>
                <c:pt idx="15">
                  <c:v>DQA1*01:03\DQB1*06:01 (DQ6)</c:v>
                </c:pt>
                <c:pt idx="16">
                  <c:v>DQA1*01:03\DQB1*06:03 (DQ6)</c:v>
                </c:pt>
                <c:pt idx="17">
                  <c:v>DQA1*02:01\DQB1*03:01 (DQ7)</c:v>
                </c:pt>
                <c:pt idx="18">
                  <c:v>DQA1*03:01\DQB1*03:01 (DQ7)</c:v>
                </c:pt>
                <c:pt idx="19">
                  <c:v>DQA1*05:03\DQB1*03:01 (DQ7)</c:v>
                </c:pt>
                <c:pt idx="20">
                  <c:v>DQA1*05:05\DQB1*03:01 (DQ7)</c:v>
                </c:pt>
                <c:pt idx="21">
                  <c:v>DQA1*06:01\DQB1*03:01 (DQ7)</c:v>
                </c:pt>
                <c:pt idx="22">
                  <c:v>DQA1*01:01\DQB1*03:02 (DQ8)</c:v>
                </c:pt>
                <c:pt idx="23">
                  <c:v>DQA1*02:01 DQB1*03:02 (DQ8)</c:v>
                </c:pt>
                <c:pt idx="24">
                  <c:v>DQA1*03:01\DQB1*03:02 (DQ8)</c:v>
                </c:pt>
                <c:pt idx="25">
                  <c:v>DQA1*03:02\DQB1*03:02 (DQ8)</c:v>
                </c:pt>
                <c:pt idx="26">
                  <c:v>DQA1*02:01\DQB1*03:03 (DQ9)</c:v>
                </c:pt>
                <c:pt idx="27">
                  <c:v>DQA1*03:01\DQB1*03:03 (DQ9)</c:v>
                </c:pt>
                <c:pt idx="28">
                  <c:v>DQA1*03:02\DQB1*03:03 (DQ9)</c:v>
                </c:pt>
              </c:strCache>
            </c:strRef>
          </c:cat>
          <c:val>
            <c:numRef>
              <c:f>'Saudi ID93#23 09-146 4 hindawi'!$B$11:$AD$11</c:f>
              <c:numCache>
                <c:formatCode>_(* #,##0_);_(* \(#,##0\);_(* "-"??_);_(@_)</c:formatCode>
                <c:ptCount val="29"/>
                <c:pt idx="0">
                  <c:v>8.6</c:v>
                </c:pt>
                <c:pt idx="1">
                  <c:v>14.0661157024793</c:v>
                </c:pt>
                <c:pt idx="2">
                  <c:v>14.055555555555614</c:v>
                </c:pt>
                <c:pt idx="3">
                  <c:v>12.945945945945899</c:v>
                </c:pt>
                <c:pt idx="4">
                  <c:v>10.3189655172414</c:v>
                </c:pt>
                <c:pt idx="5">
                  <c:v>3291.6788990825698</c:v>
                </c:pt>
                <c:pt idx="6">
                  <c:v>3769.1074380165301</c:v>
                </c:pt>
                <c:pt idx="7">
                  <c:v>5561.4855072463761</c:v>
                </c:pt>
                <c:pt idx="8">
                  <c:v>4988.9248120300763</c:v>
                </c:pt>
                <c:pt idx="9">
                  <c:v>10623.608695652192</c:v>
                </c:pt>
                <c:pt idx="10">
                  <c:v>6373.6363636363603</c:v>
                </c:pt>
                <c:pt idx="11">
                  <c:v>5960.9219858156002</c:v>
                </c:pt>
                <c:pt idx="12">
                  <c:v>5835.6209677419438</c:v>
                </c:pt>
                <c:pt idx="13">
                  <c:v>7489.6101694915387</c:v>
                </c:pt>
                <c:pt idx="14">
                  <c:v>10061.053435114507</c:v>
                </c:pt>
                <c:pt idx="15">
                  <c:v>8449.4716981132096</c:v>
                </c:pt>
                <c:pt idx="16">
                  <c:v>9359.640625</c:v>
                </c:pt>
                <c:pt idx="17">
                  <c:v>13.401574803149607</c:v>
                </c:pt>
                <c:pt idx="18">
                  <c:v>23.649122807017488</c:v>
                </c:pt>
                <c:pt idx="19">
                  <c:v>13.4700854700855</c:v>
                </c:pt>
                <c:pt idx="20">
                  <c:v>15.671140939597302</c:v>
                </c:pt>
                <c:pt idx="21">
                  <c:v>8.8938053097345104</c:v>
                </c:pt>
                <c:pt idx="22">
                  <c:v>17.662420382165571</c:v>
                </c:pt>
                <c:pt idx="23">
                  <c:v>15.149606299212607</c:v>
                </c:pt>
                <c:pt idx="24">
                  <c:v>19.380952380952401</c:v>
                </c:pt>
                <c:pt idx="25">
                  <c:v>23.880733944954077</c:v>
                </c:pt>
                <c:pt idx="26">
                  <c:v>24.458715596330279</c:v>
                </c:pt>
                <c:pt idx="27">
                  <c:v>16.539823008849613</c:v>
                </c:pt>
                <c:pt idx="28">
                  <c:v>6.6495726495726499</c:v>
                </c:pt>
              </c:numCache>
            </c:numRef>
          </c:val>
        </c:ser>
        <c:axId val="584710784"/>
        <c:axId val="588586368"/>
      </c:barChart>
      <c:catAx>
        <c:axId val="584710784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 b="0">
                    <a:latin typeface="Arial" pitchFamily="34" charset="0"/>
                    <a:cs typeface="Arial" pitchFamily="34" charset="0"/>
                  </a:defRPr>
                </a:pPr>
                <a:r>
                  <a:rPr lang="en-US" sz="1100" b="0">
                    <a:latin typeface="Arial" pitchFamily="34" charset="0"/>
                    <a:cs typeface="Arial" pitchFamily="34" charset="0"/>
                  </a:rPr>
                  <a:t>HLA DQ Single Antigen beads specificities</a:t>
                </a:r>
              </a:p>
            </c:rich>
          </c:tx>
          <c:layout/>
        </c:title>
        <c:tickLblPos val="nextTo"/>
        <c:txPr>
          <a:bodyPr rot="-5400000" vert="horz"/>
          <a:lstStyle/>
          <a:p>
            <a:pPr>
              <a:defRPr/>
            </a:pPr>
            <a:endParaRPr lang="en-US"/>
          </a:p>
        </c:txPr>
        <c:crossAx val="588586368"/>
        <c:crosses val="autoZero"/>
        <c:auto val="1"/>
        <c:lblAlgn val="ctr"/>
        <c:lblOffset val="100"/>
      </c:catAx>
      <c:valAx>
        <c:axId val="588586368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 sz="1100" b="0">
                    <a:latin typeface="Arial" pitchFamily="34" charset="0"/>
                    <a:cs typeface="Arial" pitchFamily="34" charset="0"/>
                  </a:defRPr>
                </a:pPr>
                <a:r>
                  <a:rPr lang="en-US" sz="1100" b="0">
                    <a:latin typeface="Arial" pitchFamily="34" charset="0"/>
                    <a:cs typeface="Arial" pitchFamily="34" charset="0"/>
                  </a:rPr>
                  <a:t>Fluorescence Intensity (MFI)</a:t>
                </a:r>
              </a:p>
            </c:rich>
          </c:tx>
          <c:layout>
            <c:manualLayout>
              <c:xMode val="edge"/>
              <c:yMode val="edge"/>
              <c:x val="4.4647838591102664E-3"/>
              <c:y val="8.4526360546414117E-2"/>
            </c:manualLayout>
          </c:layout>
        </c:title>
        <c:numFmt formatCode="_(* #,##0_);_(* \(#,##0\);_(* &quot;-&quot;??_);_(@_)" sourceLinked="1"/>
        <c:tickLblPos val="nextTo"/>
        <c:crossAx val="584710784"/>
        <c:crosses val="autoZero"/>
        <c:crossBetween val="between"/>
      </c:valAx>
    </c:plotArea>
    <c:plotVisOnly val="1"/>
    <c:dispBlanksAs val="gap"/>
  </c:chart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6895</cdr:x>
      <cdr:y>0.05129</cdr:y>
    </cdr:to>
    <cdr:sp macro="" textlink="">
      <cdr:nvSpPr>
        <cdr:cNvPr id="2" name="TextBox 3"/>
        <cdr:cNvSpPr txBox="1"/>
      </cdr:nvSpPr>
      <cdr:spPr>
        <a:xfrm xmlns:a="http://schemas.openxmlformats.org/drawingml/2006/main">
          <a:off x="0" y="0"/>
          <a:ext cx="609462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r>
            <a:rPr lang="el-GR" sz="1000" dirty="0" smtClean="0">
              <a:solidFill>
                <a:sysClr val="window" lastClr="FFFFFF"/>
              </a:solidFill>
              <a:latin typeface="Arial" pitchFamily="34" charset="0"/>
              <a:cs typeface="Arial" pitchFamily="34" charset="0"/>
            </a:rPr>
            <a:t>β</a:t>
          </a:r>
          <a:r>
            <a:rPr lang="en-US" sz="1000" dirty="0" smtClean="0">
              <a:solidFill>
                <a:sysClr val="window" lastClr="FFFFFF"/>
              </a:solidFill>
              <a:latin typeface="Arial" pitchFamily="34" charset="0"/>
              <a:cs typeface="Arial" pitchFamily="34" charset="0"/>
            </a:rPr>
            <a:t> chain</a:t>
          </a:r>
          <a:endParaRPr lang="en-US" sz="1000" dirty="0">
            <a:solidFill>
              <a:sysClr val="window" lastClr="FFFFFF"/>
            </a:solidFill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81897</cdr:x>
      <cdr:y>0.1746</cdr:y>
    </cdr:from>
    <cdr:to>
      <cdr:x>0.82759</cdr:x>
      <cdr:y>0.20635</cdr:y>
    </cdr:to>
    <cdr:sp macro="" textlink="">
      <cdr:nvSpPr>
        <cdr:cNvPr id="4" name="Straight Arrow Connector 3"/>
        <cdr:cNvSpPr/>
      </cdr:nvSpPr>
      <cdr:spPr>
        <a:xfrm xmlns:a="http://schemas.openxmlformats.org/drawingml/2006/main" flipH="1">
          <a:off x="7239000" y="838201"/>
          <a:ext cx="76200" cy="152400"/>
        </a:xfrm>
        <a:prstGeom xmlns:a="http://schemas.openxmlformats.org/drawingml/2006/main" prst="straightConnector1">
          <a:avLst/>
        </a:prstGeom>
        <a:ln xmlns:a="http://schemas.openxmlformats.org/drawingml/2006/main">
          <a:tailEnd type="arrow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F23D2-F76E-4895-BDA0-52F2E1EBF56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A72A3-2231-4AF2-B53B-BA5DCF084F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F23D2-F76E-4895-BDA0-52F2E1EBF56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A72A3-2231-4AF2-B53B-BA5DCF084F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F23D2-F76E-4895-BDA0-52F2E1EBF56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A72A3-2231-4AF2-B53B-BA5DCF084F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F23D2-F76E-4895-BDA0-52F2E1EBF56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A72A3-2231-4AF2-B53B-BA5DCF084F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F23D2-F76E-4895-BDA0-52F2E1EBF56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A72A3-2231-4AF2-B53B-BA5DCF084F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F23D2-F76E-4895-BDA0-52F2E1EBF56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A72A3-2231-4AF2-B53B-BA5DCF084F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F23D2-F76E-4895-BDA0-52F2E1EBF56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A72A3-2231-4AF2-B53B-BA5DCF084F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F23D2-F76E-4895-BDA0-52F2E1EBF56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A72A3-2231-4AF2-B53B-BA5DCF084F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F23D2-F76E-4895-BDA0-52F2E1EBF56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A72A3-2231-4AF2-B53B-BA5DCF084F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F23D2-F76E-4895-BDA0-52F2E1EBF56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A72A3-2231-4AF2-B53B-BA5DCF084F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F23D2-F76E-4895-BDA0-52F2E1EBF56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A72A3-2231-4AF2-B53B-BA5DCF084F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CF23D2-F76E-4895-BDA0-52F2E1EBF564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A72A3-2231-4AF2-B53B-BA5DCF084FAB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12"/>
          <p:cNvGrpSpPr/>
          <p:nvPr/>
        </p:nvGrpSpPr>
        <p:grpSpPr>
          <a:xfrm>
            <a:off x="76200" y="838200"/>
            <a:ext cx="8915400" cy="4876800"/>
            <a:chOff x="76200" y="838200"/>
            <a:chExt cx="8915400" cy="4876800"/>
          </a:xfrm>
        </p:grpSpPr>
        <p:grpSp>
          <p:nvGrpSpPr>
            <p:cNvPr id="9" name="Group 10"/>
            <p:cNvGrpSpPr/>
            <p:nvPr/>
          </p:nvGrpSpPr>
          <p:grpSpPr>
            <a:xfrm>
              <a:off x="152400" y="914400"/>
              <a:ext cx="8839200" cy="4800600"/>
              <a:chOff x="152400" y="914400"/>
              <a:chExt cx="8839200" cy="4800600"/>
            </a:xfrm>
          </p:grpSpPr>
          <p:graphicFrame>
            <p:nvGraphicFramePr>
              <p:cNvPr id="2" name="Chart 1"/>
              <p:cNvGraphicFramePr/>
              <p:nvPr/>
            </p:nvGraphicFramePr>
            <p:xfrm>
              <a:off x="152400" y="914400"/>
              <a:ext cx="8839200" cy="4800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pic>
            <p:nvPicPr>
              <p:cNvPr id="3" name="Picture 2" descr="DQ epitope 2007 pos 52P 55R.png"/>
              <p:cNvPicPr>
                <a:picLocks noChangeAspect="1"/>
              </p:cNvPicPr>
              <p:nvPr/>
            </p:nvPicPr>
            <p:blipFill>
              <a:blip r:embed="rId3" cstate="print"/>
              <a:srcRect l="30000" t="22017" r="40833" b="7203"/>
              <a:stretch>
                <a:fillRect/>
              </a:stretch>
            </p:blipFill>
            <p:spPr>
              <a:xfrm>
                <a:off x="6400800" y="1524000"/>
                <a:ext cx="1578935" cy="1939834"/>
              </a:xfrm>
              <a:prstGeom prst="rect">
                <a:avLst/>
              </a:prstGeom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6637020" y="1790700"/>
                <a:ext cx="769763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300" b="1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en-US" sz="1300" b="1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 chain</a:t>
                </a:r>
                <a:endParaRPr lang="en-US" sz="13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7162800" y="2209800"/>
                <a:ext cx="771365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300" b="1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α</a:t>
                </a:r>
                <a:r>
                  <a:rPr lang="en-US" sz="1300" b="1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 chain</a:t>
                </a:r>
                <a:endParaRPr lang="en-US" sz="13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7239000" y="1600200"/>
                <a:ext cx="70403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Peptide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8" name="Straight Arrow Connector 7"/>
              <p:cNvCxnSpPr/>
              <p:nvPr/>
            </p:nvCxnSpPr>
            <p:spPr>
              <a:xfrm flipH="1">
                <a:off x="7351580" y="1800780"/>
                <a:ext cx="76200" cy="152400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6896100" y="2030075"/>
                <a:ext cx="465192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55R</a:t>
                </a:r>
              </a:p>
              <a:p>
                <a:endParaRPr lang="en-US" sz="12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  <a:p>
                <a:r>
                  <a:rPr lang="en-US" sz="1200" b="1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52P</a:t>
                </a:r>
                <a:endParaRPr lang="en-US" sz="12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2" name="Rectangle 11"/>
            <p:cNvSpPr/>
            <p:nvPr/>
          </p:nvSpPr>
          <p:spPr>
            <a:xfrm>
              <a:off x="76200" y="838200"/>
              <a:ext cx="8915400" cy="4876800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-33010"/>
            <a:ext cx="8915400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Figure H 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HLA class II DQB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2007 shared by DQ4,5,6 antigens and define by 52P+55R on the beta chain of the DQ antigens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2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dim</dc:creator>
  <cp:lastModifiedBy>Nadim</cp:lastModifiedBy>
  <cp:revision>1</cp:revision>
  <dcterms:created xsi:type="dcterms:W3CDTF">2017-03-12T04:16:24Z</dcterms:created>
  <dcterms:modified xsi:type="dcterms:W3CDTF">2017-03-12T04:17:32Z</dcterms:modified>
</cp:coreProperties>
</file>